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TRLs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1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 gray</c:v>
                </c:pt>
                <c:pt idx="1">
                  <c:v>1 gray / 20min</c:v>
                </c:pt>
                <c:pt idx="2">
                  <c:v>1 gray / 1h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</c:v>
                </c:pt>
                <c:pt idx="1">
                  <c:v>45</c:v>
                </c:pt>
                <c:pt idx="2">
                  <c:v>1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X3CR1s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1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 gray</c:v>
                </c:pt>
                <c:pt idx="1">
                  <c:v>1 gray / 20min</c:v>
                </c:pt>
                <c:pt idx="2">
                  <c:v>1 gray / 1h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2</c:v>
                </c:pt>
                <c:pt idx="1">
                  <c:v>11</c:v>
                </c:pt>
                <c:pt idx="2">
                  <c:v>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9361808"/>
        <c:axId val="809367968"/>
      </c:barChart>
      <c:catAx>
        <c:axId val="809361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9367968"/>
        <c:crosses val="autoZero"/>
        <c:auto val="1"/>
        <c:lblAlgn val="ctr"/>
        <c:lblOffset val="100"/>
        <c:noMultiLvlLbl val="0"/>
      </c:catAx>
      <c:valAx>
        <c:axId val="8093679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Number of loci/cell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936180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8.899541064625309E-2"/>
          <c:y val="8.3678815172846921E-2"/>
          <c:w val="0.12353079827641189"/>
          <c:h val="0.238436697751987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47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51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88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665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899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438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241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436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905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413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462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5804A-9CA8-4E8C-BC3F-A9D11B883AA3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74878-53D4-45D1-A5A3-B6438EB2B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84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image" Target="../media/image9.jpeg"/><Relationship Id="rId5" Type="http://schemas.openxmlformats.org/officeDocument/2006/relationships/image" Target="../media/image4.jpeg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389511" cy="252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ie et al, Supplementary 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3" descr="F:\08072015\caov3 20min\0 ctrl merge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0303" y="1081170"/>
            <a:ext cx="1905004" cy="14275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F:\08072015\caov3 20min\0 cx merge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040" y="2544358"/>
            <a:ext cx="1909605" cy="143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8" descr="F:\08072015\caov3 20min\1 cx merge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6479" y="2544357"/>
            <a:ext cx="1883746" cy="14223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7" descr="F:\08072015\CAOV3 24HR\1 cx merge 2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27"/>
          <a:stretch/>
        </p:blipFill>
        <p:spPr bwMode="auto">
          <a:xfrm>
            <a:off x="4579179" y="2544357"/>
            <a:ext cx="1861878" cy="14180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386940" y="812801"/>
            <a:ext cx="5544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 gray                         1 gray / 20min after radiation        1 gray / 24h after radiatio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591674" y="2370888"/>
            <a:ext cx="23336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R1si                      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Lsi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15023" y="1088706"/>
            <a:ext cx="6960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H2AX</a:t>
            </a:r>
          </a:p>
          <a:p>
            <a:r>
              <a:rPr lang="en-US" sz="1000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m</a:t>
            </a:r>
            <a:r>
              <a:rPr lang="en-US" sz="1000" dirty="0" smtClean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erge</a:t>
            </a:r>
            <a:endParaRPr lang="en-US" sz="1000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802484" y="2391573"/>
            <a:ext cx="478322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Chart 16"/>
          <p:cNvGraphicFramePr/>
          <p:nvPr>
            <p:extLst>
              <p:ext uri="{D42A27DB-BD31-4B8C-83A1-F6EECF244321}">
                <p14:modId xmlns:p14="http://schemas.microsoft.com/office/powerpoint/2010/main" val="2177933042"/>
              </p:ext>
            </p:extLst>
          </p:nvPr>
        </p:nvGraphicFramePr>
        <p:xfrm>
          <a:off x="112890" y="4109155"/>
          <a:ext cx="6491110" cy="1761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19" name="Straight Connector 18"/>
          <p:cNvCxnSpPr/>
          <p:nvPr/>
        </p:nvCxnSpPr>
        <p:spPr>
          <a:xfrm>
            <a:off x="3285067" y="4560712"/>
            <a:ext cx="5983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175956" y="4459111"/>
            <a:ext cx="5983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397956" y="4391379"/>
            <a:ext cx="37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00132" y="4295421"/>
            <a:ext cx="37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5383741" y="3109820"/>
            <a:ext cx="208845" cy="206411"/>
          </a:xfrm>
          <a:prstGeom prst="rect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/>
          <p:cNvSpPr/>
          <p:nvPr/>
        </p:nvSpPr>
        <p:spPr>
          <a:xfrm>
            <a:off x="5249732" y="1311049"/>
            <a:ext cx="182880" cy="135854"/>
          </a:xfrm>
          <a:prstGeom prst="rect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3539266" y="1277880"/>
            <a:ext cx="231223" cy="234865"/>
          </a:xfrm>
          <a:prstGeom prst="rect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5" name="Picture 8" descr="F:\08072015\caov3 20min\1 cx merge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41" t="54674" r="62921" b="35236"/>
          <a:stretch/>
        </p:blipFill>
        <p:spPr bwMode="auto">
          <a:xfrm>
            <a:off x="2655778" y="3535362"/>
            <a:ext cx="408791" cy="430306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3183997" y="3286460"/>
            <a:ext cx="203201" cy="222007"/>
          </a:xfrm>
          <a:prstGeom prst="rect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6" name="Picture 4" descr="F:\08072015\caov3 20min\0 cx merge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09" t="81965" r="70111" b="4743"/>
          <a:stretch/>
        </p:blipFill>
        <p:spPr bwMode="auto">
          <a:xfrm>
            <a:off x="2060626" y="3405153"/>
            <a:ext cx="554019" cy="570155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Rectangle 26"/>
          <p:cNvSpPr/>
          <p:nvPr/>
        </p:nvSpPr>
        <p:spPr>
          <a:xfrm>
            <a:off x="1063813" y="3689872"/>
            <a:ext cx="222372" cy="251006"/>
          </a:xfrm>
          <a:prstGeom prst="rect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8" name="Picture 3" descr="F:\08072015\caov3 20min\0 ctrl merge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17" r="29875" b="82058"/>
          <a:stretch/>
        </p:blipFill>
        <p:spPr bwMode="auto">
          <a:xfrm>
            <a:off x="1975227" y="1739977"/>
            <a:ext cx="640080" cy="767352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Rectangle 28"/>
          <p:cNvSpPr/>
          <p:nvPr/>
        </p:nvSpPr>
        <p:spPr>
          <a:xfrm>
            <a:off x="1785769" y="1091927"/>
            <a:ext cx="274857" cy="284536"/>
          </a:xfrm>
          <a:prstGeom prst="rect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7" name="Group 36"/>
          <p:cNvGrpSpPr/>
          <p:nvPr/>
        </p:nvGrpSpPr>
        <p:grpSpPr>
          <a:xfrm>
            <a:off x="4579810" y="1088706"/>
            <a:ext cx="1861475" cy="1419668"/>
            <a:chOff x="6510212" y="1088706"/>
            <a:chExt cx="1861475" cy="1376222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1330"/>
            <a:stretch/>
          </p:blipFill>
          <p:spPr>
            <a:xfrm>
              <a:off x="6510212" y="1088707"/>
              <a:ext cx="1861475" cy="1376221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10" t="19605" r="22437" b="63776"/>
            <a:stretch/>
          </p:blipFill>
          <p:spPr>
            <a:xfrm>
              <a:off x="6510236" y="1088706"/>
              <a:ext cx="632178" cy="63217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36" name="Rectangle 35"/>
            <p:cNvSpPr/>
            <p:nvPr/>
          </p:nvSpPr>
          <p:spPr>
            <a:xfrm>
              <a:off x="7765909" y="1365705"/>
              <a:ext cx="208845" cy="206411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38" name="Picture 7" descr="F:\08072015\CAOV3 24HR\1 cx merge 2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02" t="39983" r="45426" b="42795"/>
          <a:stretch/>
        </p:blipFill>
        <p:spPr bwMode="auto">
          <a:xfrm>
            <a:off x="5685122" y="3273770"/>
            <a:ext cx="756356" cy="688624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9" name="Group 8"/>
          <p:cNvGrpSpPr/>
          <p:nvPr/>
        </p:nvGrpSpPr>
        <p:grpSpPr>
          <a:xfrm>
            <a:off x="2649815" y="1084403"/>
            <a:ext cx="1888485" cy="1416664"/>
            <a:chOff x="2614645" y="-526347"/>
            <a:chExt cx="1888485" cy="1416664"/>
          </a:xfrm>
        </p:grpSpPr>
        <p:pic>
          <p:nvPicPr>
            <p:cNvPr id="39" name="Picture 7" descr="F:\08072015\caov3 20min\1 ctrl merge 2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14645" y="-524509"/>
              <a:ext cx="1888485" cy="14148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0" name="Picture 7" descr="F:\08072015\caov3 20min\1 ctrl merge 2.jpg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60" t="60088" r="37289" b="20353"/>
            <a:stretch/>
          </p:blipFill>
          <p:spPr bwMode="auto">
            <a:xfrm>
              <a:off x="2614645" y="-526347"/>
              <a:ext cx="618978" cy="590844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" name="Rectangle 40"/>
            <p:cNvSpPr/>
            <p:nvPr/>
          </p:nvSpPr>
          <p:spPr>
            <a:xfrm rot="16200000">
              <a:off x="3551853" y="343982"/>
              <a:ext cx="216905" cy="264834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93373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32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14</cp:revision>
  <cp:lastPrinted>2016-10-21T18:42:10Z</cp:lastPrinted>
  <dcterms:created xsi:type="dcterms:W3CDTF">2016-10-21T17:49:58Z</dcterms:created>
  <dcterms:modified xsi:type="dcterms:W3CDTF">2018-02-12T16:24:20Z</dcterms:modified>
</cp:coreProperties>
</file>